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51D8B-DBF8-46E1-9320-27CD1E9B8E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8D0F7-510B-44AB-A32A-F1A3301E82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955B4-F40D-4638-B7A4-22853B23A9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05C74-E425-46BB-9D0E-D7BE5EA04C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24877-1670-45C1-8DB9-EF5FF3C717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F9F85-F6F6-4CA7-BD8D-0B9F85FFB3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05486-7F5E-4133-AFB4-84EEDD0B3B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80861-0E4B-4253-98A4-67A204FAC5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8E89D-9835-4AFB-A346-EAF0AA0482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CC558-B803-43E3-A89D-8538889C30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4749E-9A81-4DE5-B569-D0F075DA20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6085F-906E-4FE1-AA98-EFECCA25A6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680FD4-9CF1-4CCE-A992-C39D9638029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5240" y="5997240"/>
            <a:ext cx="6481800" cy="86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data file 6 </a:t>
            </a:r>
            <a:r>
              <a:rPr b="1" lang="en-GB" sz="13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Enhanced Ni tolerance conferred by disruption of the Tna1 and Fur4 transport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rowth of WT,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tna1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∆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nd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 fur4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∆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trains was examined by spot assays carried out on metal-free YPD and on the same medium supplemented with NiCl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3.5 mM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273400" y="2340000"/>
            <a:ext cx="2543040" cy="319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8T11:23:05Z</dcterms:created>
  <dc:creator>Roberta</dc:creator>
  <dc:description/>
  <dc:language>en-US</dc:language>
  <cp:lastModifiedBy>Dipartimento di Biochimica e Biologia Molecolare</cp:lastModifiedBy>
  <dcterms:modified xsi:type="dcterms:W3CDTF">2008-04-04T15:08:12Z</dcterms:modified>
  <cp:revision>11</cp:revision>
  <dc:subject/>
  <dc:title>Diapositiva 1</dc:title>
</cp:coreProperties>
</file>